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56" userDrawn="1">
          <p15:clr>
            <a:srgbClr val="A4A3A4"/>
          </p15:clr>
        </p15:guide>
        <p15:guide id="2" pos="56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6"/>
    <p:restoredTop sz="80480"/>
  </p:normalViewPr>
  <p:slideViewPr>
    <p:cSldViewPr snapToGrid="0" snapToObjects="1" showGuides="1">
      <p:cViewPr varScale="1">
        <p:scale>
          <a:sx n="87" d="100"/>
          <a:sy n="87" d="100"/>
        </p:scale>
        <p:origin x="1200" y="192"/>
      </p:cViewPr>
      <p:guideLst>
        <p:guide orient="horz" pos="3456"/>
        <p:guide pos="568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A2A542-8CE7-AF46-94E1-A1FE9DC505EE}" type="datetimeFigureOut">
              <a:rPr lang="en-US" smtClean="0"/>
              <a:t>5/18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29047F-FF1F-AB47-81D1-B40EF3EC4C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3854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29047F-FF1F-AB47-81D1-B40EF3EC4C5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35084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D37782-D869-0EEB-1211-E957B4A7BA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30B2F20-45A8-E877-02D3-33F8DB881D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3DB417-8F7A-D1F3-88BE-B141316766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E0DA6-E613-C149-9A1B-391777938F5D}" type="datetimeFigureOut">
              <a:rPr lang="en-US" smtClean="0"/>
              <a:t>5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FF48AA-B195-D5C2-79D2-CB056C3E3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E653BB-EB41-54F0-A9F7-2FC1FFA1D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F21D8-6AE8-DD40-B945-53097A48F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241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A374C7-8801-0CFC-9DC0-B5C55B95EB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FB59F8-E263-DDD6-F270-02A21F3E52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721F7A-8E04-6C3F-02EA-E091E4FE3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E0DA6-E613-C149-9A1B-391777938F5D}" type="datetimeFigureOut">
              <a:rPr lang="en-US" smtClean="0"/>
              <a:t>5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5E1164-9EAD-AEAE-9878-B71D542A6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53D2AC-3281-E77F-B701-2FDE0C6A6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F21D8-6AE8-DD40-B945-53097A48F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632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F806CE-4576-6AC3-1675-A8E513451D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2B44E8-46F4-40E7-9B4B-DBA8D36096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4D0897-4C8D-B17D-9964-7603D6B7BB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E0DA6-E613-C149-9A1B-391777938F5D}" type="datetimeFigureOut">
              <a:rPr lang="en-US" smtClean="0"/>
              <a:t>5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244195-5647-067B-E522-84F98DE34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92813C-43EC-9E87-C4D7-34E94C2A5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F21D8-6AE8-DD40-B945-53097A48F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3528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7C4721-B668-A486-89E5-7A3DFEC596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9511F9-DF82-AC1D-7D8A-D96BE7A887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BBFE4A-9632-06AD-5582-AC846E95D2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E0DA6-E613-C149-9A1B-391777938F5D}" type="datetimeFigureOut">
              <a:rPr lang="en-US" smtClean="0"/>
              <a:t>5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F361DA-89E7-949A-2EDB-AA302B603A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1CC5BB-EBB5-EE01-9217-3BA4F568E8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F21D8-6AE8-DD40-B945-53097A48F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59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9B4975-1DD1-A662-A451-A0C72020BE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0FEE13-D02D-962B-9382-4393D0A4C8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04426D-6D5A-D99D-8A5F-EDC0F54F0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E0DA6-E613-C149-9A1B-391777938F5D}" type="datetimeFigureOut">
              <a:rPr lang="en-US" smtClean="0"/>
              <a:t>5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3B0F5D-501B-0538-68ED-E84986FC8A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994DFD-63E0-F9F3-1859-7C1121DEAB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F21D8-6AE8-DD40-B945-53097A48F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604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286A5F-DDF3-1323-2B8F-C69CE92F46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B6FB2F-4065-183B-3A2C-D2B592927E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34424DC-D452-9324-CD29-019C3D81AB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7BD6B7-AE4F-B2C7-EF08-1585535C2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E0DA6-E613-C149-9A1B-391777938F5D}" type="datetimeFigureOut">
              <a:rPr lang="en-US" smtClean="0"/>
              <a:t>5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E13F84-3FD3-E175-0A2E-59F843D0D6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5F442D-AFF1-4C17-2A36-A280AC4A4C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F21D8-6AE8-DD40-B945-53097A48F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939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715E87-E9FA-9236-7788-E9733AB2A9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9562DB-F348-CC36-C446-3D8005B318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AD1272-1C76-123D-E3A0-01656BA199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3127F14-9BF0-97A3-1AF1-B5723B00F1E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D3A4AD5-9D49-9EA8-69CD-BF42AB0ED08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BD0D0ED-5B53-09F3-6891-19157A708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E0DA6-E613-C149-9A1B-391777938F5D}" type="datetimeFigureOut">
              <a:rPr lang="en-US" smtClean="0"/>
              <a:t>5/1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096837-5641-C972-2504-574710C3D1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EF7EC27-C7DC-E1F4-BA35-8E0056BEB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F21D8-6AE8-DD40-B945-53097A48F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548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98D43B-990C-0A7F-E7A1-EBC35BE376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858E9E3-84C1-56A4-89D9-7F0F9A201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E0DA6-E613-C149-9A1B-391777938F5D}" type="datetimeFigureOut">
              <a:rPr lang="en-US" smtClean="0"/>
              <a:t>5/1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638D77D-8C97-FDAA-4DE4-9F64786B18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024811E-0E4A-3023-BAF9-1953D4BE4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F21D8-6AE8-DD40-B945-53097A48F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192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3AF73AB-81B2-5B93-E6FA-6D1A2F3F5A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E0DA6-E613-C149-9A1B-391777938F5D}" type="datetimeFigureOut">
              <a:rPr lang="en-US" smtClean="0"/>
              <a:t>5/1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561A11-86B5-5C1E-E2F5-0A911D3FA3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AF8E02B-84F0-8536-3C2E-A375C8AB69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F21D8-6AE8-DD40-B945-53097A48F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8168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6CDCBA-AC25-0854-B086-6192353E59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D60603-6581-57BE-1FE3-4BAFD9F1CAB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3D017C-ECA1-4AF3-3BD4-4E1F07F66E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7D9CE6E-F12A-A5A4-9352-3FA295BDB6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E0DA6-E613-C149-9A1B-391777938F5D}" type="datetimeFigureOut">
              <a:rPr lang="en-US" smtClean="0"/>
              <a:t>5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F85FE7-9232-ECA1-4363-4F8D887794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91E115-0332-15CF-B2F4-BFC98809A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F21D8-6AE8-DD40-B945-53097A48F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544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D1D6B1-92C4-7E57-E635-D5BA0773A5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D8FDD6C-9E42-D1B6-0756-48618EE237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1A8295-1E94-76CD-CE9C-B2D04FA1EB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64B960-F685-BA22-D72F-BE684A569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E0DA6-E613-C149-9A1B-391777938F5D}" type="datetimeFigureOut">
              <a:rPr lang="en-US" smtClean="0"/>
              <a:t>5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5C1D65-1C49-AD72-88A0-A56A77501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EA3C2C-51C8-A3CE-60CD-F4B5A4A411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F21D8-6AE8-DD40-B945-53097A48F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231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464367A-4BFC-9D7D-2CE4-5E4DB8D80E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3C664E-CBF0-5BF4-5A48-BD9E1FF36F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FE2AFA-F9B1-4E11-5F95-ADDB2144426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1E0DA6-E613-C149-9A1B-391777938F5D}" type="datetimeFigureOut">
              <a:rPr lang="en-US" smtClean="0"/>
              <a:t>5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1C9FA0-24D4-E968-B7B5-4283FFD7E2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E0D5DC-536E-1C76-2402-08FE013A19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7F21D8-6AE8-DD40-B945-53097A48F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12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5D03F067-DF34-EBE6-E18E-2B266348C8A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69" b="2294"/>
          <a:stretch/>
        </p:blipFill>
        <p:spPr>
          <a:xfrm>
            <a:off x="913521" y="1028357"/>
            <a:ext cx="5545823" cy="469112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0C2EADEA-8BE5-6A42-F0EC-BC037C1E0330}"/>
              </a:ext>
            </a:extLst>
          </p:cNvPr>
          <p:cNvSpPr txBox="1"/>
          <p:nvPr/>
        </p:nvSpPr>
        <p:spPr>
          <a:xfrm>
            <a:off x="2707546" y="5671649"/>
            <a:ext cx="6385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𝛽</a:t>
            </a:r>
            <a:r>
              <a:rPr lang="en-US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392E3A5-7091-3C63-FA20-0BE39C11834B}"/>
              </a:ext>
            </a:extLst>
          </p:cNvPr>
          <p:cNvSpPr txBox="1"/>
          <p:nvPr/>
        </p:nvSpPr>
        <p:spPr>
          <a:xfrm>
            <a:off x="3652660" y="5671649"/>
            <a:ext cx="13495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𝛽</a:t>
            </a:r>
            <a:r>
              <a:rPr lang="en-US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Bgtx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4F36100-2079-6E7F-584F-540F2804E639}"/>
              </a:ext>
            </a:extLst>
          </p:cNvPr>
          <p:cNvSpPr txBox="1"/>
          <p:nvPr/>
        </p:nvSpPr>
        <p:spPr>
          <a:xfrm>
            <a:off x="5312848" y="5671649"/>
            <a:ext cx="6385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𝛽</a:t>
            </a:r>
            <a:r>
              <a:rPr lang="en-US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v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CCC24BC-C053-E16E-A181-E6840AB18109}"/>
              </a:ext>
            </a:extLst>
          </p:cNvPr>
          <p:cNvSpPr txBox="1"/>
          <p:nvPr/>
        </p:nvSpPr>
        <p:spPr>
          <a:xfrm>
            <a:off x="1303815" y="5671649"/>
            <a:ext cx="8348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C7A1A0B-A10D-DA4A-0A70-6FAE55476F2A}"/>
              </a:ext>
            </a:extLst>
          </p:cNvPr>
          <p:cNvSpPr txBox="1"/>
          <p:nvPr/>
        </p:nvSpPr>
        <p:spPr>
          <a:xfrm>
            <a:off x="486357" y="5322890"/>
            <a:ext cx="504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F8E23DA-9AD7-AD23-886A-2565FA63DC0C}"/>
              </a:ext>
            </a:extLst>
          </p:cNvPr>
          <p:cNvSpPr txBox="1"/>
          <p:nvPr/>
        </p:nvSpPr>
        <p:spPr>
          <a:xfrm>
            <a:off x="486357" y="4445855"/>
            <a:ext cx="504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0FD95E8-95BB-B98A-9432-792E24C623B7}"/>
              </a:ext>
            </a:extLst>
          </p:cNvPr>
          <p:cNvSpPr txBox="1"/>
          <p:nvPr/>
        </p:nvSpPr>
        <p:spPr>
          <a:xfrm>
            <a:off x="486357" y="3568818"/>
            <a:ext cx="504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0B91D72-CD1A-D280-598A-0E4074DE584A}"/>
              </a:ext>
            </a:extLst>
          </p:cNvPr>
          <p:cNvSpPr txBox="1"/>
          <p:nvPr/>
        </p:nvSpPr>
        <p:spPr>
          <a:xfrm>
            <a:off x="486357" y="2691781"/>
            <a:ext cx="504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4D16303-2A9C-6758-65AA-78FFD040D70B}"/>
              </a:ext>
            </a:extLst>
          </p:cNvPr>
          <p:cNvSpPr txBox="1"/>
          <p:nvPr/>
        </p:nvSpPr>
        <p:spPr>
          <a:xfrm>
            <a:off x="486357" y="1814744"/>
            <a:ext cx="504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E8014F0-844D-610E-CF59-C0B09309FA93}"/>
              </a:ext>
            </a:extLst>
          </p:cNvPr>
          <p:cNvSpPr txBox="1"/>
          <p:nvPr/>
        </p:nvSpPr>
        <p:spPr>
          <a:xfrm>
            <a:off x="486357" y="937707"/>
            <a:ext cx="504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FAA3A83-EEC6-A3EA-1B8B-364262EEB856}"/>
              </a:ext>
            </a:extLst>
          </p:cNvPr>
          <p:cNvSpPr txBox="1"/>
          <p:nvPr/>
        </p:nvSpPr>
        <p:spPr>
          <a:xfrm rot="16200000">
            <a:off x="-812525" y="3242549"/>
            <a:ext cx="25242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ability (percent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8F40B4E-6189-4D7E-EAA8-0F288F009A55}"/>
              </a:ext>
            </a:extLst>
          </p:cNvPr>
          <p:cNvSpPr txBox="1"/>
          <p:nvPr/>
        </p:nvSpPr>
        <p:spPr>
          <a:xfrm>
            <a:off x="6723235" y="2505670"/>
            <a:ext cx="511480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: Trypan blue was used to measure cell viability across treatment conditions. The percent of viable cells is shown using the control condition as a reference (100%). No significant effect was seen between the </a:t>
            </a:r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reatment groups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9412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65</Words>
  <Application>Microsoft Macintosh PowerPoint</Application>
  <PresentationFormat>Widescreen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sincla2</dc:creator>
  <cp:lastModifiedBy>psincla2</cp:lastModifiedBy>
  <cp:revision>7</cp:revision>
  <dcterms:created xsi:type="dcterms:W3CDTF">2022-05-17T18:03:22Z</dcterms:created>
  <dcterms:modified xsi:type="dcterms:W3CDTF">2022-05-18T13:50:00Z</dcterms:modified>
</cp:coreProperties>
</file>